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2" d="100"/>
          <a:sy n="52" d="100"/>
        </p:scale>
        <p:origin x="246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39222-2118-4216-9475-1C72B5945330}" type="datetimeFigureOut">
              <a:rPr lang="en-GB" smtClean="0"/>
              <a:t>04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D01C2-8C72-4E68-B7F8-9C8C968C37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2401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39222-2118-4216-9475-1C72B5945330}" type="datetimeFigureOut">
              <a:rPr lang="en-GB" smtClean="0"/>
              <a:t>04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D01C2-8C72-4E68-B7F8-9C8C968C37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4043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39222-2118-4216-9475-1C72B5945330}" type="datetimeFigureOut">
              <a:rPr lang="en-GB" smtClean="0"/>
              <a:t>04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D01C2-8C72-4E68-B7F8-9C8C968C37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25650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39222-2118-4216-9475-1C72B5945330}" type="datetimeFigureOut">
              <a:rPr lang="en-GB" smtClean="0"/>
              <a:t>04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D01C2-8C72-4E68-B7F8-9C8C968C37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9500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39222-2118-4216-9475-1C72B5945330}" type="datetimeFigureOut">
              <a:rPr lang="en-GB" smtClean="0"/>
              <a:t>04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D01C2-8C72-4E68-B7F8-9C8C968C37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7243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39222-2118-4216-9475-1C72B5945330}" type="datetimeFigureOut">
              <a:rPr lang="en-GB" smtClean="0"/>
              <a:t>04/08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D01C2-8C72-4E68-B7F8-9C8C968C37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79500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39222-2118-4216-9475-1C72B5945330}" type="datetimeFigureOut">
              <a:rPr lang="en-GB" smtClean="0"/>
              <a:t>04/08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D01C2-8C72-4E68-B7F8-9C8C968C37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99053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39222-2118-4216-9475-1C72B5945330}" type="datetimeFigureOut">
              <a:rPr lang="en-GB" smtClean="0"/>
              <a:t>04/08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D01C2-8C72-4E68-B7F8-9C8C968C37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49314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39222-2118-4216-9475-1C72B5945330}" type="datetimeFigureOut">
              <a:rPr lang="en-GB" smtClean="0"/>
              <a:t>04/08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D01C2-8C72-4E68-B7F8-9C8C968C37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54136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39222-2118-4216-9475-1C72B5945330}" type="datetimeFigureOut">
              <a:rPr lang="en-GB" smtClean="0"/>
              <a:t>04/08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D01C2-8C72-4E68-B7F8-9C8C968C37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2904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39222-2118-4216-9475-1C72B5945330}" type="datetimeFigureOut">
              <a:rPr lang="en-GB" smtClean="0"/>
              <a:t>04/08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D01C2-8C72-4E68-B7F8-9C8C968C37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49088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939222-2118-4216-9475-1C72B5945330}" type="datetimeFigureOut">
              <a:rPr lang="en-GB" smtClean="0"/>
              <a:t>04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1D01C2-8C72-4E68-B7F8-9C8C968C37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3261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>
            <a:off x="0" y="8559063"/>
            <a:ext cx="6858000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Supplementary Figure 2</a:t>
            </a:r>
            <a:r>
              <a:rPr lang="en-US" sz="1100" dirty="0" smtClean="0"/>
              <a:t> – </a:t>
            </a:r>
            <a:r>
              <a:rPr lang="en-US" sz="1100" dirty="0"/>
              <a:t>Principal Component Analysis (PCA) of </a:t>
            </a:r>
            <a:r>
              <a:rPr lang="en-US" sz="1100" dirty="0" smtClean="0"/>
              <a:t>DNA </a:t>
            </a:r>
            <a:r>
              <a:rPr lang="en-US" sz="1100" dirty="0"/>
              <a:t>methylation profiles </a:t>
            </a:r>
            <a:r>
              <a:rPr lang="en-US" sz="1100" dirty="0" smtClean="0"/>
              <a:t>from all CMS2 and CMS3 samples present in the MATCH and TCGA cohorts</a:t>
            </a:r>
          </a:p>
          <a:p>
            <a:endParaRPr lang="en-GB" sz="1100" dirty="0"/>
          </a:p>
          <a:p>
            <a:r>
              <a:rPr lang="en-US" sz="1100" dirty="0" smtClean="0"/>
              <a:t>Principal components were calculated for DNA </a:t>
            </a:r>
            <a:r>
              <a:rPr lang="en-US" sz="1100" dirty="0"/>
              <a:t>methylation profiles </a:t>
            </a:r>
            <a:r>
              <a:rPr lang="en-US" sz="1100" dirty="0" smtClean="0"/>
              <a:t>of 286 colorectal cancer tissues (242 CMS2 samples (black) and 44 CMS3 samples). In </a:t>
            </a:r>
            <a:r>
              <a:rPr lang="en-US" sz="1100" b="1" dirty="0" smtClean="0"/>
              <a:t>A. </a:t>
            </a:r>
            <a:r>
              <a:rPr lang="en-US" sz="1100" dirty="0" smtClean="0"/>
              <a:t>PC1 is shown on the X-axis and PC2 on the y-axis. In </a:t>
            </a:r>
            <a:r>
              <a:rPr lang="en-US" sz="1100" b="1" dirty="0" smtClean="0"/>
              <a:t>B. </a:t>
            </a:r>
            <a:r>
              <a:rPr lang="en-US" sz="1100" dirty="0" smtClean="0"/>
              <a:t>PC1 is shown on the x-axis and PC3 in the y-axis. In </a:t>
            </a:r>
            <a:r>
              <a:rPr lang="en-US" sz="1100" b="1" dirty="0" smtClean="0"/>
              <a:t>C. </a:t>
            </a:r>
            <a:r>
              <a:rPr lang="en-US" sz="1100" dirty="0" smtClean="0"/>
              <a:t>PC2 is shown on the x-axis and PC3 on the y-axis. Each dot represents 1 sample. Samples are colored based on CMS classification (CMS2 in black and CMS3 in red).</a:t>
            </a:r>
            <a:endParaRPr lang="en-US" sz="1100" dirty="0"/>
          </a:p>
        </p:txBody>
      </p:sp>
      <p:grpSp>
        <p:nvGrpSpPr>
          <p:cNvPr id="31" name="Group 30"/>
          <p:cNvGrpSpPr/>
          <p:nvPr/>
        </p:nvGrpSpPr>
        <p:grpSpPr>
          <a:xfrm>
            <a:off x="133350" y="8292"/>
            <a:ext cx="6519943" cy="8439776"/>
            <a:chOff x="133350" y="8292"/>
            <a:chExt cx="6519943" cy="8439776"/>
          </a:xfrm>
        </p:grpSpPr>
        <p:grpSp>
          <p:nvGrpSpPr>
            <p:cNvPr id="6" name="Group 5"/>
            <p:cNvGrpSpPr/>
            <p:nvPr/>
          </p:nvGrpSpPr>
          <p:grpSpPr>
            <a:xfrm>
              <a:off x="4957843" y="1159240"/>
              <a:ext cx="1695450" cy="513695"/>
              <a:chOff x="5988080" y="6900233"/>
              <a:chExt cx="1695450" cy="513695"/>
            </a:xfrm>
          </p:grpSpPr>
          <p:sp>
            <p:nvSpPr>
              <p:cNvPr id="7" name="TextBox 6"/>
              <p:cNvSpPr txBox="1"/>
              <p:nvPr/>
            </p:nvSpPr>
            <p:spPr>
              <a:xfrm>
                <a:off x="6521480" y="6900233"/>
                <a:ext cx="116205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100" dirty="0" smtClean="0"/>
                  <a:t>CMS3</a:t>
                </a:r>
                <a:endParaRPr lang="en-GB" sz="1100" dirty="0"/>
              </a:p>
            </p:txBody>
          </p:sp>
          <p:sp>
            <p:nvSpPr>
              <p:cNvPr id="8" name="Rectangle 7"/>
              <p:cNvSpPr/>
              <p:nvPr/>
            </p:nvSpPr>
            <p:spPr>
              <a:xfrm>
                <a:off x="5988080" y="7221336"/>
                <a:ext cx="542926" cy="123575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6521480" y="7152318"/>
                <a:ext cx="116205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100" dirty="0" smtClean="0"/>
                  <a:t>CMS2</a:t>
                </a:r>
                <a:endParaRPr lang="en-GB" sz="1100" dirty="0"/>
              </a:p>
            </p:txBody>
          </p:sp>
          <p:sp>
            <p:nvSpPr>
              <p:cNvPr id="10" name="Rectangle 9"/>
              <p:cNvSpPr/>
              <p:nvPr/>
            </p:nvSpPr>
            <p:spPr>
              <a:xfrm>
                <a:off x="5988080" y="6978323"/>
                <a:ext cx="542926" cy="12357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3" name="Group 12"/>
            <p:cNvGrpSpPr/>
            <p:nvPr/>
          </p:nvGrpSpPr>
          <p:grpSpPr>
            <a:xfrm>
              <a:off x="4957843" y="6783426"/>
              <a:ext cx="1695450" cy="513695"/>
              <a:chOff x="5988080" y="6900233"/>
              <a:chExt cx="1695450" cy="513695"/>
            </a:xfrm>
          </p:grpSpPr>
          <p:sp>
            <p:nvSpPr>
              <p:cNvPr id="14" name="TextBox 13"/>
              <p:cNvSpPr txBox="1"/>
              <p:nvPr/>
            </p:nvSpPr>
            <p:spPr>
              <a:xfrm>
                <a:off x="6521480" y="6900233"/>
                <a:ext cx="116205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100" dirty="0" smtClean="0"/>
                  <a:t>CMS3</a:t>
                </a:r>
                <a:endParaRPr lang="en-GB" sz="1100" dirty="0"/>
              </a:p>
            </p:txBody>
          </p:sp>
          <p:sp>
            <p:nvSpPr>
              <p:cNvPr id="15" name="Rectangle 14"/>
              <p:cNvSpPr/>
              <p:nvPr/>
            </p:nvSpPr>
            <p:spPr>
              <a:xfrm>
                <a:off x="5988080" y="7221336"/>
                <a:ext cx="542926" cy="123575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6521480" y="7152318"/>
                <a:ext cx="116205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100" dirty="0" smtClean="0"/>
                  <a:t>CMS2</a:t>
                </a:r>
                <a:endParaRPr lang="en-GB" sz="1100" dirty="0"/>
              </a:p>
            </p:txBody>
          </p:sp>
          <p:sp>
            <p:nvSpPr>
              <p:cNvPr id="17" name="Rectangle 16"/>
              <p:cNvSpPr/>
              <p:nvPr/>
            </p:nvSpPr>
            <p:spPr>
              <a:xfrm>
                <a:off x="5988080" y="6978323"/>
                <a:ext cx="542926" cy="12357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20" name="Group 19"/>
            <p:cNvGrpSpPr/>
            <p:nvPr/>
          </p:nvGrpSpPr>
          <p:grpSpPr>
            <a:xfrm>
              <a:off x="4957843" y="3974830"/>
              <a:ext cx="1695450" cy="513695"/>
              <a:chOff x="5988080" y="6900233"/>
              <a:chExt cx="1695450" cy="513695"/>
            </a:xfrm>
          </p:grpSpPr>
          <p:sp>
            <p:nvSpPr>
              <p:cNvPr id="21" name="TextBox 20"/>
              <p:cNvSpPr txBox="1"/>
              <p:nvPr/>
            </p:nvSpPr>
            <p:spPr>
              <a:xfrm>
                <a:off x="6521480" y="6900233"/>
                <a:ext cx="116205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100" dirty="0" smtClean="0"/>
                  <a:t>CMS3</a:t>
                </a:r>
                <a:endParaRPr lang="en-GB" sz="1100" dirty="0"/>
              </a:p>
            </p:txBody>
          </p:sp>
          <p:sp>
            <p:nvSpPr>
              <p:cNvPr id="22" name="Rectangle 21"/>
              <p:cNvSpPr/>
              <p:nvPr/>
            </p:nvSpPr>
            <p:spPr>
              <a:xfrm>
                <a:off x="5988080" y="7221336"/>
                <a:ext cx="542926" cy="123575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6521480" y="7152318"/>
                <a:ext cx="116205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100" dirty="0" smtClean="0"/>
                  <a:t>CMS2</a:t>
                </a:r>
                <a:endParaRPr lang="en-GB" sz="1100" dirty="0"/>
              </a:p>
            </p:txBody>
          </p:sp>
          <p:sp>
            <p:nvSpPr>
              <p:cNvPr id="24" name="Rectangle 23"/>
              <p:cNvSpPr/>
              <p:nvPr/>
            </p:nvSpPr>
            <p:spPr>
              <a:xfrm>
                <a:off x="5988080" y="6978323"/>
                <a:ext cx="542926" cy="12357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6" name="TextBox 25"/>
            <p:cNvSpPr txBox="1"/>
            <p:nvPr/>
          </p:nvSpPr>
          <p:spPr>
            <a:xfrm>
              <a:off x="133350" y="335541"/>
              <a:ext cx="59055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100" b="1" dirty="0" smtClean="0"/>
                <a:t>A.</a:t>
              </a:r>
              <a:endParaRPr lang="en-GB" sz="1100" b="1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33350" y="3145371"/>
              <a:ext cx="59055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100" b="1" dirty="0"/>
                <a:t>B</a:t>
              </a:r>
              <a:r>
                <a:rPr lang="nl-NL" sz="1100" b="1" dirty="0" smtClean="0"/>
                <a:t>.</a:t>
              </a:r>
              <a:endParaRPr lang="en-GB" sz="1100" b="1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33350" y="5961358"/>
              <a:ext cx="59055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100" b="1" dirty="0" smtClean="0"/>
                <a:t>C.</a:t>
              </a:r>
              <a:endParaRPr lang="en-GB" sz="1100" b="1" dirty="0"/>
            </a:p>
          </p:txBody>
        </p:sp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3963" y="8292"/>
              <a:ext cx="4107180" cy="2815590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3963" y="2823882"/>
              <a:ext cx="4107180" cy="2815590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3963" y="5632478"/>
              <a:ext cx="4107180" cy="281559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2777079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131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Erasmus 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.M. Wilting</dc:creator>
  <cp:lastModifiedBy>Inge van den Berg</cp:lastModifiedBy>
  <cp:revision>4</cp:revision>
  <dcterms:created xsi:type="dcterms:W3CDTF">2021-06-02T08:41:55Z</dcterms:created>
  <dcterms:modified xsi:type="dcterms:W3CDTF">2021-08-04T13:15:15Z</dcterms:modified>
</cp:coreProperties>
</file>